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9AAA5-DF5B-44BC-873D-12E95B65BF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2C4A4-8D33-4D85-90E6-DB6271B99A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D3742-40AE-4330-8940-0A6493086C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DAFC64-019F-4CB3-A88E-E7DAAC8B2C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DA215-228E-467E-9CB0-01C714957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87739-9E98-49A2-B1FD-63C5FC6E4E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E55F5-B407-47BD-BE30-9F287CC09B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4A3AE-0D3C-4153-BF78-61A21C6BB4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5FB19-FA64-4770-A864-FC8052FFCA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7DA45-7A44-4D1E-A62C-02471CD945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FC4A83-2D43-4C89-A4EF-22059D0844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68602-4D2D-4499-A5C1-4D0F72441D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2B2965-0ED2-424B-B7B0-ED798FD5E2F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81200" y="97164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58680" y="97164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76240" y="971640"/>
            <a:ext cx="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"/>
          <p:cNvGrpSpPr/>
          <p:nvPr/>
        </p:nvGrpSpPr>
        <p:grpSpPr>
          <a:xfrm>
            <a:off x="115920" y="382680"/>
            <a:ext cx="5977080" cy="603360"/>
            <a:chOff x="115920" y="382680"/>
            <a:chExt cx="5977080" cy="603360"/>
          </a:xfrm>
        </p:grpSpPr>
        <p:sp>
          <p:nvSpPr>
            <p:cNvPr id="45" name=""/>
            <p:cNvSpPr/>
            <p:nvPr/>
          </p:nvSpPr>
          <p:spPr>
            <a:xfrm>
              <a:off x="115920" y="876240"/>
              <a:ext cx="1630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860480" y="876240"/>
              <a:ext cx="1866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838680" y="876240"/>
              <a:ext cx="533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567320" y="876240"/>
              <a:ext cx="1525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4160" y="768240"/>
              <a:ext cx="34128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flipV="1">
              <a:off x="1719360" y="804600"/>
              <a:ext cx="6336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1827360" y="804600"/>
              <a:ext cx="6336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V="1">
              <a:off x="3695760" y="804600"/>
              <a:ext cx="6336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flipV="1">
              <a:off x="3805200" y="804600"/>
              <a:ext cx="6192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4343400" y="804600"/>
              <a:ext cx="6336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4535640" y="804600"/>
              <a:ext cx="6336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07440" y="73836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003320" y="768240"/>
              <a:ext cx="252360" cy="21600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80640" y="7398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I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79320" y="768240"/>
              <a:ext cx="2793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81480" y="739800"/>
              <a:ext cx="26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746440" y="768240"/>
              <a:ext cx="24588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739240" y="739800"/>
              <a:ext cx="25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130480" y="768240"/>
              <a:ext cx="23472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098800" y="739800"/>
              <a:ext cx="29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I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049560" y="768240"/>
              <a:ext cx="208080" cy="21600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002040" y="739800"/>
              <a:ext cx="29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V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672080" y="76824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851360" y="76824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953600" y="73980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VI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963960" y="768240"/>
              <a:ext cx="246240" cy="21600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924000" y="739800"/>
              <a:ext cx="34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</a:rPr>
                <a:t>V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78880" y="38268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R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38360" y="619200"/>
              <a:ext cx="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"/>
          <p:cNvSpPr/>
          <p:nvPr/>
        </p:nvSpPr>
        <p:spPr>
          <a:xfrm>
            <a:off x="2160" y="120600"/>
            <a:ext cx="92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Bdn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ge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"/>
          <p:cNvGrpSpPr/>
          <p:nvPr/>
        </p:nvGrpSpPr>
        <p:grpSpPr>
          <a:xfrm>
            <a:off x="254160" y="1952640"/>
            <a:ext cx="6390360" cy="246240"/>
            <a:chOff x="254160" y="1952640"/>
            <a:chExt cx="6390360" cy="246240"/>
          </a:xfrm>
        </p:grpSpPr>
        <p:sp>
          <p:nvSpPr>
            <p:cNvPr id="76" name=""/>
            <p:cNvSpPr/>
            <p:nvPr/>
          </p:nvSpPr>
          <p:spPr>
            <a:xfrm>
              <a:off x="547560" y="2070000"/>
              <a:ext cx="4176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54160" y="1962000"/>
              <a:ext cx="34128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672080" y="196200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851360" y="196200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168"/>
            <p:cNvSpPr/>
            <p:nvPr/>
          </p:nvSpPr>
          <p:spPr>
            <a:xfrm>
              <a:off x="6049440" y="1952640"/>
              <a:ext cx="59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" name=""/>
          <p:cNvGrpSpPr/>
          <p:nvPr/>
        </p:nvGrpSpPr>
        <p:grpSpPr>
          <a:xfrm>
            <a:off x="679320" y="2687760"/>
            <a:ext cx="6070320" cy="246240"/>
            <a:chOff x="679320" y="2687760"/>
            <a:chExt cx="6070320" cy="246240"/>
          </a:xfrm>
        </p:grpSpPr>
        <p:sp>
          <p:nvSpPr>
            <p:cNvPr id="82" name=""/>
            <p:cNvSpPr/>
            <p:nvPr/>
          </p:nvSpPr>
          <p:spPr>
            <a:xfrm>
              <a:off x="836640" y="2806920"/>
              <a:ext cx="4176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79320" y="2698920"/>
              <a:ext cx="20340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672080" y="269892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851360" y="269892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169"/>
            <p:cNvSpPr/>
            <p:nvPr/>
          </p:nvSpPr>
          <p:spPr>
            <a:xfrm>
              <a:off x="6049080" y="268776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I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" name=""/>
          <p:cNvGrpSpPr/>
          <p:nvPr/>
        </p:nvGrpSpPr>
        <p:grpSpPr>
          <a:xfrm>
            <a:off x="679320" y="3054240"/>
            <a:ext cx="6063840" cy="246240"/>
            <a:chOff x="679320" y="3054240"/>
            <a:chExt cx="6063840" cy="246240"/>
          </a:xfrm>
        </p:grpSpPr>
        <p:sp>
          <p:nvSpPr>
            <p:cNvPr id="88" name=""/>
            <p:cNvSpPr/>
            <p:nvPr/>
          </p:nvSpPr>
          <p:spPr>
            <a:xfrm>
              <a:off x="907920" y="3173400"/>
              <a:ext cx="4176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79320" y="3065400"/>
              <a:ext cx="2793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672080" y="306540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851360" y="306540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 Box 170"/>
            <p:cNvSpPr/>
            <p:nvPr/>
          </p:nvSpPr>
          <p:spPr>
            <a:xfrm>
              <a:off x="6048720" y="3054240"/>
              <a:ext cx="69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I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" name=""/>
          <p:cNvGrpSpPr/>
          <p:nvPr/>
        </p:nvGrpSpPr>
        <p:grpSpPr>
          <a:xfrm>
            <a:off x="1003320" y="3422520"/>
            <a:ext cx="5711040" cy="246240"/>
            <a:chOff x="1003320" y="3422520"/>
            <a:chExt cx="5711040" cy="246240"/>
          </a:xfrm>
        </p:grpSpPr>
        <p:sp>
          <p:nvSpPr>
            <p:cNvPr id="94" name=""/>
            <p:cNvSpPr/>
            <p:nvPr/>
          </p:nvSpPr>
          <p:spPr>
            <a:xfrm>
              <a:off x="1195560" y="3540240"/>
              <a:ext cx="4176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003320" y="3432240"/>
              <a:ext cx="252360" cy="21600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672080" y="343224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851360" y="343224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71"/>
            <p:cNvSpPr/>
            <p:nvPr/>
          </p:nvSpPr>
          <p:spPr>
            <a:xfrm>
              <a:off x="6049080" y="342252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" name=""/>
          <p:cNvGrpSpPr/>
          <p:nvPr/>
        </p:nvGrpSpPr>
        <p:grpSpPr>
          <a:xfrm>
            <a:off x="2130480" y="3789360"/>
            <a:ext cx="4597920" cy="246240"/>
            <a:chOff x="2130480" y="3789360"/>
            <a:chExt cx="4597920" cy="246240"/>
          </a:xfrm>
        </p:grpSpPr>
        <p:sp>
          <p:nvSpPr>
            <p:cNvPr id="100" name=""/>
            <p:cNvSpPr/>
            <p:nvPr/>
          </p:nvSpPr>
          <p:spPr>
            <a:xfrm>
              <a:off x="2276640" y="3926160"/>
              <a:ext cx="302400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130480" y="3818160"/>
              <a:ext cx="234720" cy="2156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672080" y="3818160"/>
              <a:ext cx="1355760" cy="2156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851360" y="3818160"/>
              <a:ext cx="62064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72"/>
            <p:cNvSpPr/>
            <p:nvPr/>
          </p:nvSpPr>
          <p:spPr>
            <a:xfrm>
              <a:off x="6049440" y="3789360"/>
              <a:ext cx="678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5" name=""/>
          <p:cNvGrpSpPr/>
          <p:nvPr/>
        </p:nvGrpSpPr>
        <p:grpSpPr>
          <a:xfrm>
            <a:off x="2746440" y="4157640"/>
            <a:ext cx="3947040" cy="255600"/>
            <a:chOff x="2746440" y="4157640"/>
            <a:chExt cx="3947040" cy="255600"/>
          </a:xfrm>
        </p:grpSpPr>
        <p:sp>
          <p:nvSpPr>
            <p:cNvPr id="106" name=""/>
            <p:cNvSpPr/>
            <p:nvPr/>
          </p:nvSpPr>
          <p:spPr>
            <a:xfrm>
              <a:off x="2924280" y="4305240"/>
              <a:ext cx="266364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746440" y="4197240"/>
              <a:ext cx="24588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672080" y="419724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851360" y="419724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 Box 173"/>
            <p:cNvSpPr/>
            <p:nvPr/>
          </p:nvSpPr>
          <p:spPr>
            <a:xfrm>
              <a:off x="6049440" y="415764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"/>
          <p:cNvGrpSpPr/>
          <p:nvPr/>
        </p:nvGrpSpPr>
        <p:grpSpPr>
          <a:xfrm>
            <a:off x="3049560" y="4535640"/>
            <a:ext cx="3748680" cy="246240"/>
            <a:chOff x="3049560" y="4535640"/>
            <a:chExt cx="3748680" cy="246240"/>
          </a:xfrm>
        </p:grpSpPr>
        <p:sp>
          <p:nvSpPr>
            <p:cNvPr id="112" name=""/>
            <p:cNvSpPr/>
            <p:nvPr/>
          </p:nvSpPr>
          <p:spPr>
            <a:xfrm>
              <a:off x="3139920" y="4654800"/>
              <a:ext cx="230508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049560" y="4546800"/>
              <a:ext cx="208080" cy="21600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672080" y="454680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851360" y="454680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174"/>
            <p:cNvSpPr/>
            <p:nvPr/>
          </p:nvSpPr>
          <p:spPr>
            <a:xfrm>
              <a:off x="6049080" y="4535640"/>
              <a:ext cx="74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V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"/>
          <p:cNvGrpSpPr/>
          <p:nvPr/>
        </p:nvGrpSpPr>
        <p:grpSpPr>
          <a:xfrm>
            <a:off x="3049560" y="4903920"/>
            <a:ext cx="3748680" cy="246240"/>
            <a:chOff x="3049560" y="4903920"/>
            <a:chExt cx="3748680" cy="246240"/>
          </a:xfrm>
        </p:grpSpPr>
        <p:sp>
          <p:nvSpPr>
            <p:cNvPr id="118" name=""/>
            <p:cNvSpPr/>
            <p:nvPr/>
          </p:nvSpPr>
          <p:spPr>
            <a:xfrm>
              <a:off x="3139920" y="5022720"/>
              <a:ext cx="2232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049560" y="4914720"/>
              <a:ext cx="208080" cy="21564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672080" y="4914720"/>
              <a:ext cx="1355760" cy="2156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851360" y="4914720"/>
              <a:ext cx="620640" cy="215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965400" y="4914720"/>
              <a:ext cx="246240" cy="21564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175"/>
            <p:cNvSpPr/>
            <p:nvPr/>
          </p:nvSpPr>
          <p:spPr>
            <a:xfrm>
              <a:off x="6049080" y="4903920"/>
              <a:ext cx="74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VI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4" name=""/>
          <p:cNvGrpSpPr/>
          <p:nvPr/>
        </p:nvGrpSpPr>
        <p:grpSpPr>
          <a:xfrm>
            <a:off x="679320" y="2319480"/>
            <a:ext cx="6070320" cy="246240"/>
            <a:chOff x="679320" y="2319480"/>
            <a:chExt cx="6070320" cy="246240"/>
          </a:xfrm>
        </p:grpSpPr>
        <p:sp>
          <p:nvSpPr>
            <p:cNvPr id="125" name=""/>
            <p:cNvSpPr/>
            <p:nvPr/>
          </p:nvSpPr>
          <p:spPr>
            <a:xfrm>
              <a:off x="763560" y="2438640"/>
              <a:ext cx="4176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lgDash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79320" y="2330640"/>
              <a:ext cx="10980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672080" y="2330640"/>
              <a:ext cx="1355760" cy="216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851360" y="2330640"/>
              <a:ext cx="62064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176"/>
            <p:cNvSpPr/>
            <p:nvPr/>
          </p:nvSpPr>
          <p:spPr>
            <a:xfrm>
              <a:off x="6049080" y="231948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BDNF I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"/>
          <p:cNvSpPr/>
          <p:nvPr/>
        </p:nvSpPr>
        <p:spPr>
          <a:xfrm>
            <a:off x="720" y="1519200"/>
            <a:ext cx="1358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Bdnf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transcrip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725720" y="511200"/>
            <a:ext cx="88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Coding ex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657000" y="99360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750600" y="99360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838080" y="99360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44280" y="4427640"/>
            <a:ext cx="2318040" cy="720720"/>
            <a:chOff x="44280" y="4427640"/>
            <a:chExt cx="2318040" cy="720720"/>
          </a:xfrm>
        </p:grpSpPr>
        <p:sp>
          <p:nvSpPr>
            <p:cNvPr id="136" name=""/>
            <p:cNvSpPr/>
            <p:nvPr/>
          </p:nvSpPr>
          <p:spPr>
            <a:xfrm>
              <a:off x="115560" y="4498920"/>
              <a:ext cx="144720" cy="14400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15560" y="4714560"/>
              <a:ext cx="144720" cy="144360"/>
            </a:xfrm>
            <a:prstGeom prst="rect">
              <a:avLst/>
            </a:prstGeom>
            <a:solidFill>
              <a:srgbClr val="ffff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15560" y="4930560"/>
              <a:ext cx="144720" cy="144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61360" y="4427640"/>
              <a:ext cx="210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reviously characterised promo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62800" y="4686120"/>
              <a:ext cx="1514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ewly defined promot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61360" y="4902120"/>
              <a:ext cx="88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Coding ex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4280" y="4427640"/>
              <a:ext cx="2303640" cy="718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"/>
          <p:cNvSpPr/>
          <p:nvPr/>
        </p:nvSpPr>
        <p:spPr>
          <a:xfrm>
            <a:off x="-26280" y="416088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e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02T08:14:12Z</dcterms:created>
  <dc:creator>bennc</dc:creator>
  <dc:description/>
  <dc:language>en-US</dc:language>
  <cp:lastModifiedBy>bennc</cp:lastModifiedBy>
  <dcterms:modified xsi:type="dcterms:W3CDTF">2008-10-03T08:47:39Z</dcterms:modified>
  <cp:revision>6</cp:revision>
  <dc:subject/>
  <dc:title>Slide 1</dc:title>
</cp:coreProperties>
</file>